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5100"/>
  </p:normalViewPr>
  <p:slideViewPr>
    <p:cSldViewPr snapToGrid="0">
      <p:cViewPr varScale="1">
        <p:scale>
          <a:sx n="89" d="100"/>
          <a:sy n="89" d="100"/>
        </p:scale>
        <p:origin x="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ik, Seo (NIH/NLM/LHC) [E]" userId="7a9ca21e-0617-4b6c-a5ae-fc5f2cb02f0b" providerId="ADAL" clId="{501404E9-337C-CC47-96D8-29EB3539E22E}"/>
    <pc:docChg chg="modSld">
      <pc:chgData name="Baik, Seo (NIH/NLM/LHC) [E]" userId="7a9ca21e-0617-4b6c-a5ae-fc5f2cb02f0b" providerId="ADAL" clId="{501404E9-337C-CC47-96D8-29EB3539E22E}" dt="2023-04-18T20:11:41.175" v="52" actId="1076"/>
      <pc:docMkLst>
        <pc:docMk/>
      </pc:docMkLst>
      <pc:sldChg chg="addSp modSp mod">
        <pc:chgData name="Baik, Seo (NIH/NLM/LHC) [E]" userId="7a9ca21e-0617-4b6c-a5ae-fc5f2cb02f0b" providerId="ADAL" clId="{501404E9-337C-CC47-96D8-29EB3539E22E}" dt="2023-04-18T20:11:41.175" v="52" actId="1076"/>
        <pc:sldMkLst>
          <pc:docMk/>
          <pc:sldMk cId="665599487" sldId="258"/>
        </pc:sldMkLst>
        <pc:spChg chg="add mod">
          <ac:chgData name="Baik, Seo (NIH/NLM/LHC) [E]" userId="7a9ca21e-0617-4b6c-a5ae-fc5f2cb02f0b" providerId="ADAL" clId="{501404E9-337C-CC47-96D8-29EB3539E22E}" dt="2023-04-18T20:11:41.175" v="52" actId="1076"/>
          <ac:spMkLst>
            <pc:docMk/>
            <pc:sldMk cId="665599487" sldId="258"/>
            <ac:spMk id="3" creationId="{D13C4304-08C2-1750-4856-A0145725F1ED}"/>
          </ac:spMkLst>
        </pc:spChg>
        <pc:spChg chg="mod">
          <ac:chgData name="Baik, Seo (NIH/NLM/LHC) [E]" userId="7a9ca21e-0617-4b6c-a5ae-fc5f2cb02f0b" providerId="ADAL" clId="{501404E9-337C-CC47-96D8-29EB3539E22E}" dt="2023-04-18T20:10:25.067" v="3" actId="1076"/>
          <ac:spMkLst>
            <pc:docMk/>
            <pc:sldMk cId="665599487" sldId="258"/>
            <ac:spMk id="7" creationId="{2E97B610-D9E9-C69A-D5E8-100FF3DCBAF7}"/>
          </ac:spMkLst>
        </pc:spChg>
        <pc:spChg chg="mod">
          <ac:chgData name="Baik, Seo (NIH/NLM/LHC) [E]" userId="7a9ca21e-0617-4b6c-a5ae-fc5f2cb02f0b" providerId="ADAL" clId="{501404E9-337C-CC47-96D8-29EB3539E22E}" dt="2023-04-18T20:10:46.768" v="8" actId="1076"/>
          <ac:spMkLst>
            <pc:docMk/>
            <pc:sldMk cId="665599487" sldId="258"/>
            <ac:spMk id="8" creationId="{2C5B2A98-1A99-D6D7-79F4-0AC3634FB316}"/>
          </ac:spMkLst>
        </pc:spChg>
        <pc:spChg chg="mod">
          <ac:chgData name="Baik, Seo (NIH/NLM/LHC) [E]" userId="7a9ca21e-0617-4b6c-a5ae-fc5f2cb02f0b" providerId="ADAL" clId="{501404E9-337C-CC47-96D8-29EB3539E22E}" dt="2023-04-18T20:10:41.259" v="7" actId="1076"/>
          <ac:spMkLst>
            <pc:docMk/>
            <pc:sldMk cId="665599487" sldId="258"/>
            <ac:spMk id="10" creationId="{00F56B60-533B-D2DF-0F42-1A3A7CEDEB31}"/>
          </ac:spMkLst>
        </pc:spChg>
        <pc:spChg chg="mod">
          <ac:chgData name="Baik, Seo (NIH/NLM/LHC) [E]" userId="7a9ca21e-0617-4b6c-a5ae-fc5f2cb02f0b" providerId="ADAL" clId="{501404E9-337C-CC47-96D8-29EB3539E22E}" dt="2023-04-18T20:10:38.076" v="6" actId="1076"/>
          <ac:spMkLst>
            <pc:docMk/>
            <pc:sldMk cId="665599487" sldId="258"/>
            <ac:spMk id="11" creationId="{F77D3E8F-164C-16D6-1E6B-42AA3715E46F}"/>
          </ac:spMkLst>
        </pc:spChg>
        <pc:picChg chg="mod">
          <ac:chgData name="Baik, Seo (NIH/NLM/LHC) [E]" userId="7a9ca21e-0617-4b6c-a5ae-fc5f2cb02f0b" providerId="ADAL" clId="{501404E9-337C-CC47-96D8-29EB3539E22E}" dt="2023-04-18T20:10:09.060" v="0" actId="1076"/>
          <ac:picMkLst>
            <pc:docMk/>
            <pc:sldMk cId="665599487" sldId="258"/>
            <ac:picMk id="2" creationId="{00000000-0008-0000-0B00-0000BB000000}"/>
          </ac:picMkLst>
        </pc:picChg>
        <pc:picChg chg="mod">
          <ac:chgData name="Baik, Seo (NIH/NLM/LHC) [E]" userId="7a9ca21e-0617-4b6c-a5ae-fc5f2cb02f0b" providerId="ADAL" clId="{501404E9-337C-CC47-96D8-29EB3539E22E}" dt="2023-04-18T20:10:12.793" v="1" actId="1076"/>
          <ac:picMkLst>
            <pc:docMk/>
            <pc:sldMk cId="665599487" sldId="258"/>
            <ac:picMk id="5" creationId="{00000000-0008-0000-0B00-0000BC000000}"/>
          </ac:picMkLst>
        </pc:picChg>
        <pc:picChg chg="mod">
          <ac:chgData name="Baik, Seo (NIH/NLM/LHC) [E]" userId="7a9ca21e-0617-4b6c-a5ae-fc5f2cb02f0b" providerId="ADAL" clId="{501404E9-337C-CC47-96D8-29EB3539E22E}" dt="2023-04-18T20:10:18.794" v="2" actId="1076"/>
          <ac:picMkLst>
            <pc:docMk/>
            <pc:sldMk cId="665599487" sldId="258"/>
            <ac:picMk id="6" creationId="{00000000-0008-0000-0B00-0000BD000000}"/>
          </ac:picMkLst>
        </pc:picChg>
      </pc:sldChg>
    </pc:docChg>
  </pc:docChgLst>
  <pc:docChgLst>
    <pc:chgData name="Baik, Seo (NIH/NLM/LHC) [E]" userId="7a9ca21e-0617-4b6c-a5ae-fc5f2cb02f0b" providerId="ADAL" clId="{82F4C249-5C2B-0741-9F28-A943D433BC14}"/>
    <pc:docChg chg="delSld modSld">
      <pc:chgData name="Baik, Seo (NIH/NLM/LHC) [E]" userId="7a9ca21e-0617-4b6c-a5ae-fc5f2cb02f0b" providerId="ADAL" clId="{82F4C249-5C2B-0741-9F28-A943D433BC14}" dt="2023-04-26T14:41:34.008" v="2" actId="2696"/>
      <pc:docMkLst>
        <pc:docMk/>
      </pc:docMkLst>
      <pc:sldChg chg="modSp mod">
        <pc:chgData name="Baik, Seo (NIH/NLM/LHC) [E]" userId="7a9ca21e-0617-4b6c-a5ae-fc5f2cb02f0b" providerId="ADAL" clId="{82F4C249-5C2B-0741-9F28-A943D433BC14}" dt="2023-04-26T14:41:21.317" v="1" actId="20577"/>
        <pc:sldMkLst>
          <pc:docMk/>
          <pc:sldMk cId="665599487" sldId="258"/>
        </pc:sldMkLst>
        <pc:spChg chg="mod">
          <ac:chgData name="Baik, Seo (NIH/NLM/LHC) [E]" userId="7a9ca21e-0617-4b6c-a5ae-fc5f2cb02f0b" providerId="ADAL" clId="{82F4C249-5C2B-0741-9F28-A943D433BC14}" dt="2023-04-26T14:41:21.317" v="1" actId="20577"/>
          <ac:spMkLst>
            <pc:docMk/>
            <pc:sldMk cId="665599487" sldId="258"/>
            <ac:spMk id="3" creationId="{D13C4304-08C2-1750-4856-A0145725F1ED}"/>
          </ac:spMkLst>
        </pc:spChg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768806779" sldId="262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801634849" sldId="263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3837915168" sldId="264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3116523968" sldId="265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3444466311" sldId="266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4006416689" sldId="267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2242301948" sldId="268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414574665" sldId="269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2885923730" sldId="270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3762947711" sldId="271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2523822461" sldId="272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3017777936" sldId="273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3529833890" sldId="274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1975042136" sldId="275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1233247467" sldId="276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449119102" sldId="277"/>
        </pc:sldMkLst>
      </pc:sldChg>
      <pc:sldChg chg="del">
        <pc:chgData name="Baik, Seo (NIH/NLM/LHC) [E]" userId="7a9ca21e-0617-4b6c-a5ae-fc5f2cb02f0b" providerId="ADAL" clId="{82F4C249-5C2B-0741-9F28-A943D433BC14}" dt="2023-04-26T14:41:34.008" v="2" actId="2696"/>
        <pc:sldMkLst>
          <pc:docMk/>
          <pc:sldMk cId="229257237" sldId="278"/>
        </pc:sldMkLst>
      </pc:sldChg>
    </pc:docChg>
  </pc:docChgLst>
  <pc:docChgLst>
    <pc:chgData name="Baik, Seo (NIH/NLM/LHC) [E]" userId="7a9ca21e-0617-4b6c-a5ae-fc5f2cb02f0b" providerId="ADAL" clId="{5E0F8824-185B-9544-9970-B95484745CFD}"/>
    <pc:docChg chg="modSld">
      <pc:chgData name="Baik, Seo (NIH/NLM/LHC) [E]" userId="7a9ca21e-0617-4b6c-a5ae-fc5f2cb02f0b" providerId="ADAL" clId="{5E0F8824-185B-9544-9970-B95484745CFD}" dt="2023-09-01T14:30:00.054" v="6" actId="20577"/>
      <pc:docMkLst>
        <pc:docMk/>
      </pc:docMkLst>
      <pc:sldChg chg="modSp mod">
        <pc:chgData name="Baik, Seo (NIH/NLM/LHC) [E]" userId="7a9ca21e-0617-4b6c-a5ae-fc5f2cb02f0b" providerId="ADAL" clId="{5E0F8824-185B-9544-9970-B95484745CFD}" dt="2023-09-01T14:30:00.054" v="6" actId="20577"/>
        <pc:sldMkLst>
          <pc:docMk/>
          <pc:sldMk cId="665599487" sldId="258"/>
        </pc:sldMkLst>
        <pc:spChg chg="mod">
          <ac:chgData name="Baik, Seo (NIH/NLM/LHC) [E]" userId="7a9ca21e-0617-4b6c-a5ae-fc5f2cb02f0b" providerId="ADAL" clId="{5E0F8824-185B-9544-9970-B95484745CFD}" dt="2023-09-01T14:30:00.054" v="6" actId="20577"/>
          <ac:spMkLst>
            <pc:docMk/>
            <pc:sldMk cId="665599487" sldId="258"/>
            <ac:spMk id="3" creationId="{D13C4304-08C2-1750-4856-A0145725F1ED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CF05DF-539B-BF47-AB44-DB6246B16399}" type="datetimeFigureOut">
              <a:rPr lang="en-US" smtClean="0"/>
              <a:t>9/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D05ADE-B07C-6A47-892C-EE7F56FAC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774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26233-3884-C23C-3B98-95E590D027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1593CA-0A9B-8FA9-2FED-CAFDB846BA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EC16D8-AC9D-C642-96F8-66FD8224F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772605-BB80-2C34-E038-C6F1DF8E9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A05243-3135-4016-4D0D-0A7D27CC8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615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ECDD0C-0F20-9B6B-AFF9-31F1A794D3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183A73-CAD8-A2F3-C48A-D6861DB35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A5536-D9E8-7216-341C-C2E8E9971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A93FAF-6033-9662-6221-F91356272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791F1D-8039-49B6-145F-70387AC9F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85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0D4E60-356D-F20E-0491-7F5B7BCA85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3AC8F9-AD10-BBBB-66CE-6DB6BD0BC9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95D699-0DEB-C13B-E268-D97F890D3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E7B1F7-F747-1F0C-7CF0-87C097DB3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B2BAD9-E0D7-56DA-E51F-5A16130AD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856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DDF52-8DF8-316B-7FE0-C4EE35223A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1F48D-76A1-0B72-2B40-86EF5EB8CD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9ECBDC-2653-B902-C12E-B769B07EF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7BA906-59A1-4F1C-C441-F94C3ADC1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65074-CFCD-699D-BE4B-D2227B171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92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AE16C-C8D6-191F-F0AD-4FCE68955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03E70E-373F-3425-D56F-D4B460DA0E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C4F82-51C9-8746-E79F-D64F64579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0AF250-A389-A936-1789-E751D6290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5FC038-2700-B6B6-7FC9-F38732FB3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587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33B67-7D27-A6C2-7F66-52013518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0083F1-3EB4-4E43-BF2A-6943A0B4FF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72ED51-3442-0BF9-6828-833EAAC584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D85290-6442-0C64-18CD-99BAFBEF7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07C328-4BAB-C7CB-3EC5-BD805E80D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BA04FC-D3BA-B6A9-D646-F7761A485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061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BC81B-EFCE-3F59-0820-BBD5ED2314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50C17F-D724-36FD-DC09-7DCC9DC480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EFAB1F-06FF-EB89-D037-2F177BCA7C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4A924A-C592-45B2-2A0B-AD50F2CA9A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FB4FDD-AC44-4D29-6BF3-CA193A504F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D0F571-0F0A-3622-8DFE-44A7F6283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F1AB3A-E916-B17A-196D-2C1607F3D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138C46-4ECA-99AD-60AB-A772B4214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449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3DE950-6C8E-7123-5306-6375379E00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CEC03A-7106-BEEB-1425-D60C27C9B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5C2819-6B3D-704A-3C59-9A3F2C0D4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67CADB-B061-192D-3677-6403D442D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644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3D0590-6E82-50A2-0EF1-8D0367114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46DD2D-77A9-97CE-C034-A21CBD34D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0DF658-ECF0-06D9-C45B-82ACCCB59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158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6251D-B7DD-E7FB-BBE0-70516762A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FF8180-6FA8-A005-A9B3-935A475BCD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BF07C9-DB2D-4FCF-4B34-CC3A849E24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5F6898-10D7-C95F-69D4-BA8FD222C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0A3067-32A1-0658-A8AB-1D71067F1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0DFB61-AFA6-2F2A-796E-511A2D3BD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839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2DBB0-2E7E-46C5-94EA-13D9EE23C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39A10F-1BC3-4097-B124-143570EE31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B7D9CD-3A62-BA2E-E7F5-3A5E283363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3F77A7-02EE-97C4-1A01-5B215B952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2D7D50-C850-4F75-57DF-653DDF966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F8BF84-ECFC-CBBC-CFE1-C5B551756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831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286057-EF79-617E-494C-EF9700A3A7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48F0A-0AB2-AF4A-E3B5-3AE9020B1A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FCED4F-9D84-EFFD-EA24-1F7963CCB6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E4CDE4-4340-924C-83D6-5FBCEC9E1D0E}" type="datetimeFigureOut">
              <a:rPr lang="en-US" smtClean="0"/>
              <a:t>9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6CF6DC-1C60-C9CB-4A5C-975186EF8C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BA8BF0-C2F5-62B8-2FAC-ABB53BDB54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E6A9E9-DAFA-CA44-BA10-C537B0E4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485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96117" y="835543"/>
            <a:ext cx="1272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$ Total FF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BB000000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17" y="1541021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B00-0000BC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0040" y="1549399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B00-0000BD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3963" y="1541021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E97B610-D9E9-C69A-D5E8-100FF3DCBAF7}"/>
              </a:ext>
            </a:extLst>
          </p:cNvPr>
          <p:cNvSpPr txBox="1"/>
          <p:nvPr/>
        </p:nvSpPr>
        <p:spPr>
          <a:xfrm>
            <a:off x="1541924" y="1143322"/>
            <a:ext cx="771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Du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0F56B60-533B-D2DF-0F42-1A3A7CEDEB31}"/>
              </a:ext>
            </a:extLst>
          </p:cNvPr>
          <p:cNvSpPr txBox="1"/>
          <p:nvPr/>
        </p:nvSpPr>
        <p:spPr>
          <a:xfrm>
            <a:off x="5632571" y="114332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Dua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7D3E8F-164C-16D6-1E6B-42AA3715E46F}"/>
              </a:ext>
            </a:extLst>
          </p:cNvPr>
          <p:cNvSpPr txBox="1"/>
          <p:nvPr/>
        </p:nvSpPr>
        <p:spPr>
          <a:xfrm>
            <a:off x="9878710" y="1143321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ver Dua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13C4304-08C2-1750-4856-A0145725F1ED}"/>
              </a:ext>
            </a:extLst>
          </p:cNvPr>
          <p:cNvSpPr txBox="1"/>
          <p:nvPr/>
        </p:nvSpPr>
        <p:spPr>
          <a:xfrm>
            <a:off x="96117" y="139192"/>
            <a:ext cx="11999766" cy="5672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06400" marR="0" indent="-40640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Appendix Figure 2.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rends in Racial Disparities in 4 Healthcare Expenditures by Dual Eligibility</a:t>
            </a:r>
            <a:endParaRPr lang="en-US" sz="1800" kern="1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55994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96118" y="430191"/>
            <a:ext cx="1272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$ Part 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97B610-D9E9-C69A-D5E8-100FF3DCBAF7}"/>
              </a:ext>
            </a:extLst>
          </p:cNvPr>
          <p:cNvSpPr txBox="1"/>
          <p:nvPr/>
        </p:nvSpPr>
        <p:spPr>
          <a:xfrm>
            <a:off x="1676395" y="753357"/>
            <a:ext cx="771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Du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0F56B60-533B-D2DF-0F42-1A3A7CEDEB31}"/>
              </a:ext>
            </a:extLst>
          </p:cNvPr>
          <p:cNvSpPr txBox="1"/>
          <p:nvPr/>
        </p:nvSpPr>
        <p:spPr>
          <a:xfrm>
            <a:off x="5710317" y="753356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Dua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7D3E8F-164C-16D6-1E6B-42AA3715E46F}"/>
              </a:ext>
            </a:extLst>
          </p:cNvPr>
          <p:cNvSpPr txBox="1"/>
          <p:nvPr/>
        </p:nvSpPr>
        <p:spPr>
          <a:xfrm>
            <a:off x="9899731" y="744593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ver Dual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B00-0000BF000000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17" y="103035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B00-0000C0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0040" y="103035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0000000-0008-0000-0B00-0000C1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3963" y="103035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565180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96118" y="430191"/>
            <a:ext cx="1272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$ Part 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97B610-D9E9-C69A-D5E8-100FF3DCBAF7}"/>
              </a:ext>
            </a:extLst>
          </p:cNvPr>
          <p:cNvSpPr txBox="1"/>
          <p:nvPr/>
        </p:nvSpPr>
        <p:spPr>
          <a:xfrm>
            <a:off x="1676395" y="753357"/>
            <a:ext cx="771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Du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0F56B60-533B-D2DF-0F42-1A3A7CEDEB31}"/>
              </a:ext>
            </a:extLst>
          </p:cNvPr>
          <p:cNvSpPr txBox="1"/>
          <p:nvPr/>
        </p:nvSpPr>
        <p:spPr>
          <a:xfrm>
            <a:off x="5710317" y="753356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Dua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7D3E8F-164C-16D6-1E6B-42AA3715E46F}"/>
              </a:ext>
            </a:extLst>
          </p:cNvPr>
          <p:cNvSpPr txBox="1"/>
          <p:nvPr/>
        </p:nvSpPr>
        <p:spPr>
          <a:xfrm>
            <a:off x="9899731" y="744593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ver Dual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000000-0008-0000-0B00-0000D3000000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17" y="103035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00000-0008-0000-0B00-0000D4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0040" y="1021592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0000000-0008-0000-0B00-0000D5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3963" y="103035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018503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C5B2A98-1A99-D6D7-79F4-0AC3634FB316}"/>
              </a:ext>
            </a:extLst>
          </p:cNvPr>
          <p:cNvSpPr txBox="1"/>
          <p:nvPr/>
        </p:nvSpPr>
        <p:spPr>
          <a:xfrm>
            <a:off x="96118" y="430191"/>
            <a:ext cx="1272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$ Part 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E97B610-D9E9-C69A-D5E8-100FF3DCBAF7}"/>
              </a:ext>
            </a:extLst>
          </p:cNvPr>
          <p:cNvSpPr txBox="1"/>
          <p:nvPr/>
        </p:nvSpPr>
        <p:spPr>
          <a:xfrm>
            <a:off x="1676395" y="753357"/>
            <a:ext cx="771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Dua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0F56B60-533B-D2DF-0F42-1A3A7CEDEB31}"/>
              </a:ext>
            </a:extLst>
          </p:cNvPr>
          <p:cNvSpPr txBox="1"/>
          <p:nvPr/>
        </p:nvSpPr>
        <p:spPr>
          <a:xfrm>
            <a:off x="5710317" y="753356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al Dua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7D3E8F-164C-16D6-1E6B-42AA3715E46F}"/>
              </a:ext>
            </a:extLst>
          </p:cNvPr>
          <p:cNvSpPr txBox="1"/>
          <p:nvPr/>
        </p:nvSpPr>
        <p:spPr>
          <a:xfrm>
            <a:off x="9899731" y="744593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ver Dual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0000000-0008-0000-0B00-0000D7000000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117" y="1021592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0000000-0008-0000-0B00-0000D800000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0040" y="103035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0000000-0008-0000-0B00-0000D9000000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63963" y="1023606"/>
            <a:ext cx="3931920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35328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</TotalTime>
  <Words>59</Words>
  <Application>Microsoft Macintosh PowerPoint</Application>
  <PresentationFormat>Widescreen</PresentationFormat>
  <Paragraphs>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k, Seo (NIH/NLM/LHC) [E]</dc:creator>
  <cp:lastModifiedBy>Baik, Seo (NIH/NLM/LHC) [E]</cp:lastModifiedBy>
  <cp:revision>1</cp:revision>
  <dcterms:created xsi:type="dcterms:W3CDTF">2023-03-23T15:22:48Z</dcterms:created>
  <dcterms:modified xsi:type="dcterms:W3CDTF">2023-09-01T14:30:05Z</dcterms:modified>
</cp:coreProperties>
</file>